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58" r:id="rId2"/>
  </p:sldIdLst>
  <p:sldSz cx="6858000" cy="9902825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19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12" d="100"/>
          <a:sy n="112" d="100"/>
        </p:scale>
        <p:origin x="692" y="-1328"/>
      </p:cViewPr>
      <p:guideLst>
        <p:guide orient="horz" pos="3119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242074" y="685800"/>
            <a:ext cx="23745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233781" y="1433649"/>
            <a:ext cx="6390300" cy="39522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233775" y="5456992"/>
            <a:ext cx="6390300" cy="1526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233775" y="2129799"/>
            <a:ext cx="6390300" cy="3780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233775" y="6069481"/>
            <a:ext cx="6390300" cy="2504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233775" y="4141374"/>
            <a:ext cx="6390300" cy="16209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233775" y="856878"/>
            <a:ext cx="6390300" cy="1102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233775" y="2219044"/>
            <a:ext cx="6390300" cy="6578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233775" y="856878"/>
            <a:ext cx="6390300" cy="1102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233775" y="2219044"/>
            <a:ext cx="3000000" cy="6578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3624300" y="2219044"/>
            <a:ext cx="3000000" cy="6578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233775" y="856878"/>
            <a:ext cx="6390300" cy="1102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233775" y="1069785"/>
            <a:ext cx="2106000" cy="14550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233775" y="2675618"/>
            <a:ext cx="2106000" cy="6121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367688" y="866746"/>
            <a:ext cx="4775700" cy="7876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3429000" y="-241"/>
            <a:ext cx="3429000" cy="99036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199125" y="2374428"/>
            <a:ext cx="3033900" cy="28542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199125" y="5397207"/>
            <a:ext cx="3033900" cy="2378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3704625" y="1394177"/>
            <a:ext cx="2877600" cy="7114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233775" y="8145800"/>
            <a:ext cx="4499100" cy="11652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233775" y="856878"/>
            <a:ext cx="6390300" cy="1102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233775" y="2219044"/>
            <a:ext cx="6390300" cy="657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BCBDC35-DFA5-42EE-8FCE-C6611702789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55922858"/>
              </p:ext>
            </p:extLst>
          </p:nvPr>
        </p:nvGraphicFramePr>
        <p:xfrm>
          <a:off x="350045" y="3221825"/>
          <a:ext cx="6150768" cy="145032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73833">
                  <a:extLst>
                    <a:ext uri="{9D8B030D-6E8A-4147-A177-3AD203B41FA5}">
                      <a16:colId xmlns:a16="http://schemas.microsoft.com/office/drawing/2014/main" val="161850259"/>
                    </a:ext>
                  </a:extLst>
                </a:gridCol>
                <a:gridCol w="583933">
                  <a:extLst>
                    <a:ext uri="{9D8B030D-6E8A-4147-A177-3AD203B41FA5}">
                      <a16:colId xmlns:a16="http://schemas.microsoft.com/office/drawing/2014/main" val="363018102"/>
                    </a:ext>
                  </a:extLst>
                </a:gridCol>
                <a:gridCol w="919831">
                  <a:extLst>
                    <a:ext uri="{9D8B030D-6E8A-4147-A177-3AD203B41FA5}">
                      <a16:colId xmlns:a16="http://schemas.microsoft.com/office/drawing/2014/main" val="324253241"/>
                    </a:ext>
                  </a:extLst>
                </a:gridCol>
                <a:gridCol w="632694">
                  <a:extLst>
                    <a:ext uri="{9D8B030D-6E8A-4147-A177-3AD203B41FA5}">
                      <a16:colId xmlns:a16="http://schemas.microsoft.com/office/drawing/2014/main" val="2822469114"/>
                    </a:ext>
                  </a:extLst>
                </a:gridCol>
                <a:gridCol w="878326">
                  <a:extLst>
                    <a:ext uri="{9D8B030D-6E8A-4147-A177-3AD203B41FA5}">
                      <a16:colId xmlns:a16="http://schemas.microsoft.com/office/drawing/2014/main" val="1276012343"/>
                    </a:ext>
                  </a:extLst>
                </a:gridCol>
                <a:gridCol w="699684">
                  <a:extLst>
                    <a:ext uri="{9D8B030D-6E8A-4147-A177-3AD203B41FA5}">
                      <a16:colId xmlns:a16="http://schemas.microsoft.com/office/drawing/2014/main" val="311099227"/>
                    </a:ext>
                  </a:extLst>
                </a:gridCol>
                <a:gridCol w="662467">
                  <a:extLst>
                    <a:ext uri="{9D8B030D-6E8A-4147-A177-3AD203B41FA5}">
                      <a16:colId xmlns:a16="http://schemas.microsoft.com/office/drawing/2014/main" val="570129895"/>
                    </a:ext>
                  </a:extLst>
                </a:gridCol>
              </a:tblGrid>
              <a:tr h="121444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IN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. </a:t>
                      </a:r>
                      <a:r>
                        <a:rPr lang="en-IN" sz="9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vara</a:t>
                      </a:r>
                      <a:endParaRPr lang="en-IN" sz="900" b="1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900" b="0" i="1" u="none" strike="noStrike" cap="non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Arial"/>
                        </a:rPr>
                        <a:t>O. sativa</a:t>
                      </a:r>
                      <a:endParaRPr lang="en-IN" sz="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IN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. </a:t>
                      </a:r>
                      <a:r>
                        <a:rPr lang="en-IN" sz="9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vara</a:t>
                      </a:r>
                      <a:r>
                        <a:rPr lang="en-I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erged</a:t>
                      </a:r>
                      <a:endParaRPr lang="en-I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sz="900" b="0" i="1" u="none" strike="noStrike" cap="non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  <a:sym typeface="Arial"/>
                        </a:rPr>
                        <a:t>O. sativa</a:t>
                      </a:r>
                      <a:r>
                        <a:rPr lang="en-I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erged</a:t>
                      </a:r>
                      <a:endParaRPr lang="en-I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3374686"/>
                  </a:ext>
                </a:extLst>
              </a:tr>
              <a:tr h="82400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IN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edling</a:t>
                      </a:r>
                      <a:endParaRPr lang="en-I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agleaf/Panicle</a:t>
                      </a:r>
                      <a:endParaRPr lang="en-IN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edling</a:t>
                      </a:r>
                      <a:endParaRPr lang="en-IN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agleaf/Panicle</a:t>
                      </a:r>
                      <a:endParaRPr lang="en-IN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52018557"/>
                  </a:ext>
                </a:extLst>
              </a:tr>
              <a:tr h="15667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w Reads</a:t>
                      </a:r>
                      <a:endParaRPr lang="en-IN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517649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4138265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461562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359217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7655914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7820779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66963588"/>
                  </a:ext>
                </a:extLst>
              </a:tr>
              <a:tr h="15667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ter adaptor removal</a:t>
                      </a:r>
                      <a:endParaRPr lang="en-IN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848757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1077020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165897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455191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2925777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4621088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26841579"/>
                  </a:ext>
                </a:extLst>
              </a:tr>
              <a:tr h="15667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ngth range filtering (20-21 nt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000802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1008149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752259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124925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008951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877184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4529329"/>
                  </a:ext>
                </a:extLst>
              </a:tr>
              <a:tr h="15667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ter t-RNA and r-RNA removal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957190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0876172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716130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049211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7833362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765341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37923419"/>
                  </a:ext>
                </a:extLst>
              </a:tr>
              <a:tr h="15667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ome mapped reads</a:t>
                      </a:r>
                      <a:endParaRPr lang="en-IN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714450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577006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610814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564108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7291456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174922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23819669"/>
                  </a:ext>
                </a:extLst>
              </a:tr>
              <a:tr h="156671"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S mapped reads</a:t>
                      </a:r>
                      <a:endParaRPr lang="en-I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461016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070828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503817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600736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2531844</a:t>
                      </a:r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IN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104553</a:t>
                      </a:r>
                      <a:endParaRPr lang="en-IN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32" marR="4932" marT="4932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09106147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F49BA4AC-E0D6-48ED-AFAB-70D951C7591F}"/>
              </a:ext>
            </a:extLst>
          </p:cNvPr>
          <p:cNvSpPr txBox="1"/>
          <p:nvPr/>
        </p:nvSpPr>
        <p:spPr>
          <a:xfrm>
            <a:off x="314329" y="5246215"/>
            <a:ext cx="62865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>
                <a:solidFill>
                  <a:schemeClr val="dk1"/>
                </a:solidFill>
              </a:rPr>
              <a:t>Additional File</a:t>
            </a:r>
            <a:r>
              <a:rPr lang="en-IN" sz="1200" dirty="0"/>
              <a:t> 2: Library statistics of degradome datasets.</a:t>
            </a:r>
          </a:p>
        </p:txBody>
      </p:sp>
    </p:spTree>
    <p:extLst>
      <p:ext uri="{BB962C8B-B14F-4D97-AF65-F5344CB8AC3E}">
        <p14:creationId xmlns:p14="http://schemas.microsoft.com/office/powerpoint/2010/main" val="1329252418"/>
      </p:ext>
    </p:extLst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FFAB40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91</Words>
  <Application>Microsoft Office PowerPoint</Application>
  <PresentationFormat>Custom</PresentationFormat>
  <Paragraphs>5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Arial</vt:lpstr>
      <vt:lpstr>Simple Ligh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Swetha Chenna</cp:lastModifiedBy>
  <cp:revision>9</cp:revision>
  <dcterms:modified xsi:type="dcterms:W3CDTF">2021-10-17T11:52:43Z</dcterms:modified>
</cp:coreProperties>
</file>